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891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05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0892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0067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4047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895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7484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4319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3704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05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2501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CED5B-22B0-41D4-9CD6-A51A1CADC0AF}" type="datetimeFigureOut">
              <a:rPr lang="en-GB" smtClean="0"/>
              <a:t>25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B3DC7-0CB5-4E05-924B-F18C86BEE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0920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43808" y="1152853"/>
            <a:ext cx="1226082" cy="646331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Screened </a:t>
            </a:r>
          </a:p>
          <a:p>
            <a:pPr algn="ctr"/>
            <a:r>
              <a:rPr lang="en-GB" dirty="0" smtClean="0"/>
              <a:t>n=154 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2915816" y="4293096"/>
            <a:ext cx="1080120" cy="646331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Studied </a:t>
            </a:r>
          </a:p>
          <a:p>
            <a:pPr algn="ctr"/>
            <a:r>
              <a:rPr lang="en-GB" dirty="0" smtClean="0"/>
              <a:t>n=149 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2900247" y="2743333"/>
            <a:ext cx="1167697" cy="646331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Excluded </a:t>
            </a:r>
          </a:p>
          <a:p>
            <a:pPr algn="ctr"/>
            <a:r>
              <a:rPr lang="en-GB" dirty="0" smtClean="0"/>
              <a:t>n=5</a:t>
            </a:r>
            <a:endParaRPr lang="en-GB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3419872" y="1915091"/>
            <a:ext cx="0" cy="72182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3419872" y="3499267"/>
            <a:ext cx="0" cy="72182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2195736" y="260648"/>
            <a:ext cx="4176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Online Supporting Material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323528" y="5445224"/>
            <a:ext cx="806489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l Figure 1. Flow </a:t>
            </a:r>
            <a:r>
              <a:rPr lang="en-GB" dirty="0" smtClean="0"/>
              <a:t>chart of the study. n=3 </a:t>
            </a:r>
            <a:r>
              <a:rPr lang="en-GB" dirty="0"/>
              <a:t>subjects were excluded due to plasma biochemistry not being within the normal ranges and n=2 subjects were excluded due to BMI being outside the recruitment cut-offs</a:t>
            </a:r>
            <a:r>
              <a:rPr lang="en-GB"/>
              <a:t>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2495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7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hodson</dc:creator>
  <cp:lastModifiedBy>lhodson</cp:lastModifiedBy>
  <cp:revision>5</cp:revision>
  <dcterms:created xsi:type="dcterms:W3CDTF">2018-08-09T07:00:08Z</dcterms:created>
  <dcterms:modified xsi:type="dcterms:W3CDTF">2018-09-25T20:09:45Z</dcterms:modified>
</cp:coreProperties>
</file>